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30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623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873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45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51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102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19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87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63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71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576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81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8DE1177-A61A-7AD0-39DC-A974AD2592FC}"/>
              </a:ext>
            </a:extLst>
          </p:cNvPr>
          <p:cNvSpPr txBox="1"/>
          <p:nvPr/>
        </p:nvSpPr>
        <p:spPr>
          <a:xfrm>
            <a:off x="251860" y="5207238"/>
            <a:ext cx="8640279" cy="1750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8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x proportional h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zards model for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FS in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NBC treated with ICIs. 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FS wa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otted by Cox proportional hazards model in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TNBC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ime is presented as days from the start of immunotherapy. Patients are stratified by ICI lines. Blue lines: 1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ne; red lines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: 2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d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ne; green line: </a:t>
            </a:r>
            <a:r>
              <a:rPr lang="zh-CN" altLang="en-US" sz="1400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≥</a:t>
            </a:r>
            <a:r>
              <a:rPr lang="en-US" altLang="zh-CN" sz="1400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altLang="zh-CN" sz="1400" kern="100" baseline="300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d</a:t>
            </a:r>
            <a:r>
              <a:rPr lang="en-US" altLang="zh-CN" sz="1400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ne.</a:t>
            </a:r>
            <a:endParaRPr lang="en-US" altLang="zh-CN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 descr="图表, 条形图, 直方图&#10;&#10;描述已自动生成">
            <a:extLst>
              <a:ext uri="{FF2B5EF4-FFF2-40B4-BE49-F238E27FC236}">
                <a16:creationId xmlns:a16="http://schemas.microsoft.com/office/drawing/2014/main" id="{FDB52A1D-A158-2DEC-3AD0-70F438B9F92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34" r="1528"/>
          <a:stretch/>
        </p:blipFill>
        <p:spPr>
          <a:xfrm>
            <a:off x="251859" y="548639"/>
            <a:ext cx="8768895" cy="4504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037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7</TotalTime>
  <Words>66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 Dai</dc:creator>
  <cp:lastModifiedBy>Ying Dai</cp:lastModifiedBy>
  <cp:revision>9</cp:revision>
  <dcterms:created xsi:type="dcterms:W3CDTF">2023-12-11T13:09:18Z</dcterms:created>
  <dcterms:modified xsi:type="dcterms:W3CDTF">2023-12-11T14:24:38Z</dcterms:modified>
</cp:coreProperties>
</file>